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742113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8882D-BAEC-49D6-96B9-4052EB2342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D03C1-F74E-4C66-8679-59A4B0869A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89915-7A04-4089-90AE-AE7391B1C8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90B55-4D18-4129-B3D5-8D5C22DE52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00AAC9-CFE5-41A5-A74B-78F3EBA0CF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C3DA5A-F5C6-4947-99DD-603580364A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B98BA-E397-4D7F-ADA3-9C2E446731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0B940-C3D5-4F4C-B73D-D241C55F33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AE591-7AA2-4B57-AB70-DFDF3EDDA2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A0C59-5108-408E-BFC5-554C56CDB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322AE-9AC9-46C0-8A5B-A458145127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17CBA-0BBF-4F16-B9D9-4976D05EEB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A02F4E-14A4-48A4-855F-F42D4E1B0EA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8760" y="428760"/>
          <a:ext cx="6143400" cy="336996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Chang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523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hibitor of DNA binding 1, dominant negative helix-loop-helix protein [NM_002165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6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142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DX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oxiredoxin 4  [NM_006406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64E-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165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opomyosin 2 (beta) [NM_213674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067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E [NM_175617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61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347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KBP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K506 binding protein 9, 63 kDa [NM_007270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37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H  [NM_005951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9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250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X  [NM_005952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6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728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A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 calcium binding protein A13  [NM_005979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95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947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XA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nexin A2  [NM_001002857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59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080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ST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trin (actin depolymerizing factor) [NM_001011546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0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4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NI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rnichon homolog (Drosophila) [NM_005776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1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56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aragine synthetase (ASNS)[NM_001673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1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83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DC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iled-coil domain containing 104 [NM_080667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9E-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8006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MED10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membrane emp24-like trafficking protein 10 (yeast) pseudogene [AJ004914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9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618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2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2A [NM_005953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9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309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YNC1I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ynein, cytoplasmic, intermediate polypeptide 2 [NM_001378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72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501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complex 1  [NM_030752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7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5145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CLK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ublecortin-like kinase 3 [NM_033403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412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A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oltage-dependent anion channel 2  [NM_003375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8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912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TG1I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tuitary tumor-transforming 1 interacting protein [NM_004339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67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28760" y="3803760"/>
          <a:ext cx="6143400" cy="488304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672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IF4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ic translation initiation factor 4B [NM_00141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79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B (functional) [NM_00594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0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953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grin, beta 1 (fibronectin receptor, beta polypeptide, antigen CD29 includes MDF2, MSK12) [NM_00221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750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8or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8 open reading frame 4 (TC-1) [CR61373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5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750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TA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n-NO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nn-NO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TA binding protein 3  [NM_00100229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5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09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G [NM_00595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25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C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TB (POZ) domain containing 14B [NM_05287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67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92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CL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ccinate-CoA ligase, GDP-forming, beta subunit [NM_00384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00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277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1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llothionein 1L (gene/pseudogene) [X9726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2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28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B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B34, member RAS oncogene family  [NM_03193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3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126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4orf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4 open reading frame 34 [NM_17492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3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5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623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hibitin [NM_00263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4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NF2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inc finger protein 283 [NM_18184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2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681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HCYL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-adenosylhomocysteine hydrolase-like 1 [NM_00662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609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UFAF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DH dehydrogenase (ubiquinone) 1 alpha subcomplex, assembly factor [NM_17488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800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TG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TG family, member 3 [NM_00680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5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84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348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A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 calcium binding protein A8 (calgranulin A)  [NM_00296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00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49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78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B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hemoglobin, alpha 1 (HBA1), mRNA [NM_00055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0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6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03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S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thepsin G [NM_00191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6.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808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WA5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on Willebrand factor A domain containing 5B2 [AL83449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1.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0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B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moglobin mu chain [NM_00100393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1.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4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8313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LJ457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FLJ45717 protein [NM_20740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4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6"/>
          <p:cNvSpPr/>
          <p:nvPr/>
        </p:nvSpPr>
        <p:spPr>
          <a:xfrm>
            <a:off x="428760" y="0"/>
            <a:ext cx="6114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800" spc="-1" strike="noStrike">
                <a:solidFill>
                  <a:srgbClr val="000000"/>
                </a:solidFill>
                <a:latin typeface="Arial"/>
                <a:ea typeface="Calibri"/>
              </a:rPr>
              <a:t>Supplementary Table 1 - Genes differentially expressed in osteosarcoma.</a:t>
            </a:r>
            <a:r>
              <a:rPr b="0" lang="en-AU" sz="800" spc="-1" strike="noStrike">
                <a:solidFill>
                  <a:srgbClr val="000000"/>
                </a:solidFill>
                <a:latin typeface="Arial"/>
                <a:ea typeface="Calibri"/>
              </a:rPr>
              <a:t> List of 206 annotated genes that are significantly (</a:t>
            </a:r>
            <a:r>
              <a:rPr b="0" i="1" lang="en-AU" sz="800" spc="-1" strike="noStrike">
                <a:solidFill>
                  <a:srgbClr val="000000"/>
                </a:solidFill>
                <a:latin typeface="Arial"/>
                <a:ea typeface="Calibri"/>
              </a:rPr>
              <a:t>P </a:t>
            </a:r>
            <a:r>
              <a:rPr b="0" lang="en-AU" sz="800" spc="-1" strike="noStrike">
                <a:solidFill>
                  <a:srgbClr val="000000"/>
                </a:solidFill>
                <a:latin typeface="Arial"/>
                <a:ea typeface="Calibri"/>
              </a:rPr>
              <a:t>&lt; 0.05) up- and down-regulated in osteosarcoma biopsies in comparison with non-malignant bone. The original list comprised 305 genes flagged as present in at least half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428760" y="1643040"/>
          <a:ext cx="6143400" cy="704520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038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Y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ycine-N-acyltransferase NM_00583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67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NX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nascin XB [NM_01910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5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39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G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rdner-Rasheed feline sarcoma viral (v-fgr) oncogene homolog [NM_00524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60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I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amate receptor, ionotropic, N-methyl D-aspartate 1 [NM_02156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08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CER1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c fragment of IgE, high affinity I, receptor for; gamma polypeptide [NM_00410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53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RX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aredoxin 5 [NM_01641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79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ROB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RO protein tyrosine kinase binding protein [NM_00333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5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97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KR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korin, ring finger protein, 1 [NM_01344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023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M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disintegrin and metalloproteinase domain 33 [NM_02522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187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-related C3 botulinum toxin substrate 2 (rho family, small GTP binding protein Rac2) [NM_00287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30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RO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roporphyrinogen decarboxylase [NM_00037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46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-rel reticuloendotheliosis viral oncogene homolog A (avian) (p65) [L1906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52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843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VE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RAVER1 [NM_13345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52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370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Y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yctalopin [NM_02256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42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0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PR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hingosine-1-phosphate receptor 2 [NM_00423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798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MILIN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lastin microfibril interfacer 3 [NM_05284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1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275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17orf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17 open reading frame 72 [BC04567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8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057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ANX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ANX family, member B2 [NM_14566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6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3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S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mphocyte-specific protein 1 [NM_00101325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93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C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matopoietic cell signal transducer [NM_01426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06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B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ythrocyte membrane protein band 4.2 [NM_00011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664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1H4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one 1, H4b [NM_00354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90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CNK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tassium channel, subfamily K, member 15 [NM_02235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7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X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oquois homeobox protein 5 [NM_00585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1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DT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dix (nucleoside diphosphate linked moiety X)-type motif 13 [NM_01590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646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DR21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D repeat domain 21C [NM_15241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420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RP7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bosomal RNA processing 7 homolog B (S. cerevisiae) [NR_00218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400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NG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ukocyte receptor cluster (LRC) member 8 [NM_05292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570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E2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iquitin-conjugating enzyme E2G 2 (UBC7 homolog, yeast) [NM_18268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73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14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lute carrier family 14 (urea transporter), member 2 [NM_00716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88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R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restin, beta 2 [NM_00431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6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01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D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pamine receptor D4 [NM_00079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387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RA2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renergic, alpha-2A-, receptor [NM_00068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87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P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myl peptide receptor 1 [NM_00202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8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428760" y="642960"/>
          <a:ext cx="6143400" cy="100800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chan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37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ZU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zurocidin 1 (cationic antimicrobial protein 37)[NM_00170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6.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8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24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perdin P factor, complement [NM_00262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6.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088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MF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ia maturation factor, gamma [NM_00487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4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071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X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oquois homeobox protein 3 [NM_02433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285840" y="428760"/>
          <a:ext cx="6143400" cy="816120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39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hionine adenosyltransferase I, alpha [NM_00042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4609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, E [NM_00551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315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178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ily with sequence similarity 178, member B [NM_01649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1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210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OCK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arc/osteonectin, cwcv and kazal-like domains proteoglycan (testican) 2 [NM_01476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598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DA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one deacetylase 4 [NM_00603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901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N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lcium channel, voltage-dependent, beta 1 subunit [NM_00072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919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PH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trophilin 1 [NM_00100870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62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780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-myc myelocytomatosis viral oncogene homolog (avian) [M1392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7E-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6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ypothetical gene supported by BC042812 [BC04281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60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RR2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all proline-rich protein 2C (pseudogene) [M2153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4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64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PC0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HSPC065 protein [NM_01415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598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128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ily with sequence similarity 128, member B [AK02440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3563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DO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I, DO alpha [NM_00211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184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2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2F transcription factor 4, p107/p130-binding [NM_00195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9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RRES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oic acid receptor responder (tazarotene induced) 3 NM_00458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158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C6521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milar to Ig heavy chain V-II region ARH-77 precursor [BX24830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3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72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T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ntrophin, alpha 1 (dystrophin-associated protein A1, 59kDa, acidic component)  [NM_00309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1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8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lute carrier family 8 (sodium/calcium exchanger), member 1 [NM_02109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852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8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ase, Class I, type 8B, member 2  [NM_02045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30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BSCR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illiams-Beuren syndrome chromosome region 23 [NM_02504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676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PNS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tyrosine phosphatase, non-receptor type substrate 1  [NM_08079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8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832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17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KIAA1715 [NM_03065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554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DHHC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inc finger, DHHC domain containing 22 [NM_17497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618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LV6-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a-DK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munoglobulin lambda variable 6-57 [AF26787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796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PE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artyl aminopeptidase. [AK02300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797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elin associated glycoprotein [NM_08060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6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20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P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id phosphatase 5, tartrate resistant [NM_00161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9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759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16orf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16 open reading frame 73 [NM_15276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306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TBD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bindin [NM_03142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92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20orf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20 open reading frame 3 [NM_02053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539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A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o box A4 [NM_00214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170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B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me binding protein 1 [NM_01598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49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09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DP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I, DP alpha 1 [NM_03355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796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38A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lute carrier family 38, member 10 [NM_13857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346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02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i-FI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KIAA0240 (KIAA0240), mRNA [NM_01534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"/>
          <p:cNvGraphicFramePr/>
          <p:nvPr/>
        </p:nvGraphicFramePr>
        <p:xfrm>
          <a:off x="285840" y="785880"/>
          <a:ext cx="6143400" cy="7934400"/>
        </p:xfrm>
        <a:graphic>
          <a:graphicData uri="http://schemas.openxmlformats.org/drawingml/2006/table">
            <a:tbl>
              <a:tblPr/>
              <a:tblGrid>
                <a:gridCol w="1071360"/>
                <a:gridCol w="928800"/>
                <a:gridCol w="2714760"/>
                <a:gridCol w="500040"/>
                <a:gridCol w="92844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chan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063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L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cleolar protein 3 (apoptosis repressor with CARD domain)  [NM_00394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85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TRA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giotensin II receptor-associated protein  [NM_02035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46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DHB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ocadherin beta 13 NM_01893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16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D6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-6 partitioning defective 6 homolog gamma (C. elegans)  [NM_03251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219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XN7L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axin 7-like 3 [AL39015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52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78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PR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 protein-coupled receptor 150 [NM_19924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1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00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ZA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Z associated protein 2 [NM_01476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41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CR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chykinin receptor 2  [NM_00105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76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T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tuitary tumor-transforming 1  [NM_00421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40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GR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 guanyl releasing protein 2 (calcium and DAG-regulated)  [NM_00582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60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AT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ynurenine aminotransferase III [NM_00100866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081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L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-cell CLL/lymphoma 2  [NM_00065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601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ulin, alpha 8 [NM_01894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197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DC1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iled-coil domain containing 149 [NM_17346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93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X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ntaxin 17  [NM_01791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665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5H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lfactory receptor, family 5, subfamily H, member 1  [NM_00100533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77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79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79A antigen (immunoglobulin-associated alpha) [NM_00178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35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1orf2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1 open reading frame 226 [NM_00108537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5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76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NF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ng finger protein 167  [NM_01552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4784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MEM191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membrane protein 191B [XM_00112842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0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75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BK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i-FI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u tubulin kinase 1 [AK13121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65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K3R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sphoinositide-3-kinase, regulatory subunit 5, p101  [NM_01430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515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yrotrophic embryonic factor  [NM_00321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49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SM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yl-CoA synthetase medium-chain family member 5 [BC06851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137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, C [M2196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413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HGAP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 GTPase activating protein 27  [NM_19928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232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KRD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kyrin repeat domain 58 [CR59349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76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P2R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phosphatase 2 (formerly 2A), regulatory subunit A (PR 65), alpha isoform [NM_01422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5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08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OX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me oxygenase (decycling) 1 [NM_00213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4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88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L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-like, family 12  [NM_01656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73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889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22A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lute carrier family 22 (organic cation transporter), member 15 [NM_01842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77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16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NK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rosine kinase, non-receptor, 2 [NM_00578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99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HGAP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 GTPase activating protein 4 [NM_00166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788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P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plekin [NM_00481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9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9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HS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wth hormone secretagogue receptor [NM_00412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6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664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DP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I, DP beta 1 [NM_00212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178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01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0101 [NM_01473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73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F1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nesin family member 1C [NM_00661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88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2AF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2A histone family, member X [NM_00210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028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DT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D and tetratricopeptide repeats 1 [NM_01502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357120" y="785880"/>
          <a:ext cx="6143760" cy="7905600"/>
        </p:xfrm>
        <a:graphic>
          <a:graphicData uri="http://schemas.openxmlformats.org/drawingml/2006/table">
            <a:tbl>
              <a:tblPr/>
              <a:tblGrid>
                <a:gridCol w="1071720"/>
                <a:gridCol w="928440"/>
                <a:gridCol w="2714760"/>
                <a:gridCol w="500040"/>
                <a:gridCol w="92880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chan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8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XI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X interacting protein [AB02067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784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P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pase, endothelial [NM_00603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222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L10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S-like, family 10, member B NM_03331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9141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b-NO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.sapiens mRNA for prion protein. [X8254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999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G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gh-mobility group box 1 [NM_00212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4019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C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cision repair cross-complementing rodent repair deficiency, complementation group 2 (xeroderma pigmentosum D) [NM_00040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190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PSM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-protein signalling modulator 3 (AGS3-like, C. elegans) [NM_02210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1128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X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RY (sex determining region Y)-box 1 [NM_00598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46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6V0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ase, H+ transporting, lysosomal 38kDa, V0 subunit d isoform 1 [NM_00469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849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C6428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ypothetical LOC642852 [BC02283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873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ulin, beta, 2 [NM_00608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5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1974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LF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 Kruppel-like factor 13 (KLF13), mRNA [NM_01599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689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VX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ven-skipped homeo box homolog 1 (Drosophila)[NM_00198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17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TB4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ukotriene B4 receptor [NM_18165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9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16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HRS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hydrogenase/reductase (SDR family) member 8 [NM_01624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73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DCCAG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rologically defined colon cancer antigen 33  [NM_00578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5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38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5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ily with sequence similarity 5, member C [NM_19905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88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2G12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spholipase A2, group XIIB [NM_03256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98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MDL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M1-like 3 (S. cerevisiae) [NM_13928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851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CRL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c receptor like 2 [NM_15237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9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N9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dium channel, voltage-gated, type IX, alpha[NM_00297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839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TN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culon 3 (RTN3), transcript variant 4 [NM_20143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67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488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B561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tochrome b-561 domain containing 1 [NM_18258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94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KH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ng finger and KH domain containing 1  [NM_20330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7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RTAP4-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eratin associated protein 4-12 [NM_03185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6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L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-cell CLL/lymphoma 3 [NM_00517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435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DP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histocompatibility complex, class II, DP alpha 1 [NM_03355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8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50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KI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keletal muscle and kidney enriched inositol phosphatase [NM_130766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631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L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cell leukemia/lymphoma 6 [NM_01441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4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217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9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9 homolog A (S. pombe) [NM_00458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556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GPR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S-related GPR, member F [NM_14501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229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F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F3 RNA polymerase II, TATA box binding protein (TBP)-associated factor, 140kDa [BC07388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717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NB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lcium channel, voltage-dependent, beta 3 subunit [NM_00072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558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S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lsolin (amyloidosis, Finnish type) [NM_19825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4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2071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ncer/testis CT47 family, member 11 [NM_17357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60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AD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iquitin associated domain containing 1  [NM_01617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6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2078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R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oic acid receptor, alpha [NM_00096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"/>
          <p:cNvGraphicFramePr/>
          <p:nvPr/>
        </p:nvGraphicFramePr>
        <p:xfrm>
          <a:off x="357120" y="714240"/>
          <a:ext cx="6143760" cy="3571920"/>
        </p:xfrm>
        <a:graphic>
          <a:graphicData uri="http://schemas.openxmlformats.org/drawingml/2006/table">
            <a:tbl>
              <a:tblPr/>
              <a:tblGrid>
                <a:gridCol w="1071720"/>
                <a:gridCol w="928440"/>
                <a:gridCol w="2714760"/>
                <a:gridCol w="500040"/>
                <a:gridCol w="928800"/>
              </a:tblGrid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mb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scription and acc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ld chan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85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leukin 26[NM_01840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205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20orf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20 open reading frame 141 [NM_080739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8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30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ASLS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AS-like suppressor family, member 5 [NM_054108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4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054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AS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P1 (general receptor for phosphoinositides 1)-associated scaffold protein [NM_181711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5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56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F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ipto, FRL-1, cryptic family 1 [NM_032545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0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3922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BC1D10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BC1 domain family, member 10C [NM_19851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1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32_P405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ernally expressed 3 (non-protein coding) [BX161432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33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T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differentiated embryonic cell transcription factor 1  [NM_003577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9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687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OD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collagen-lysine, 2-oxoglutarate 5-dioxygenase 3 [NM_00108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2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528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K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IMA (never in mitosis gene a)- related kinase 8 [NM_17817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0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7286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MEM1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membrane protein 114 [XM_208930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484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M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mnionless homolog (mouse) [NM_030943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3_P1334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PX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athione peroxidase 3 (plasma) [NM_00208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5E-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_24_P9322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09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ull-length cDNA clone CS0DI059YG13 of Placenta Cot 25-normalized of Homo sapiens (human). [CR610954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80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29T02:17:42Z</dcterms:created>
  <dc:creator>lmunoz</dc:creator>
  <dc:description/>
  <dc:language>en-US</dc:language>
  <cp:lastModifiedBy>lmunoz</cp:lastModifiedBy>
  <dcterms:modified xsi:type="dcterms:W3CDTF">2009-12-18T04:41:36Z</dcterms:modified>
  <cp:revision>364</cp:revision>
  <dc:subject/>
  <dc:title>Slide 1</dc:title>
</cp:coreProperties>
</file>